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76" r:id="rId3"/>
    <p:sldId id="277" r:id="rId4"/>
    <p:sldId id="278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660"/>
  </p:normalViewPr>
  <p:slideViewPr>
    <p:cSldViewPr>
      <p:cViewPr varScale="1">
        <p:scale>
          <a:sx n="94" d="100"/>
          <a:sy n="94" d="100"/>
        </p:scale>
        <p:origin x="-108" y="-12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dirty="0" smtClean="0"/>
              <a:t>088DD</a:t>
            </a:r>
            <a:endParaRPr 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209800" y="1447800"/>
            <a:ext cx="6481978" cy="541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" y="1447800"/>
            <a:ext cx="2075234" cy="228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212728" y="4419600"/>
            <a:ext cx="189014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Stat3: </a:t>
            </a:r>
          </a:p>
          <a:p>
            <a:r>
              <a:rPr lang="en-US" dirty="0" err="1" smtClean="0"/>
              <a:t>Nuc</a:t>
            </a:r>
            <a:r>
              <a:rPr lang="en-US" dirty="0" smtClean="0"/>
              <a:t> OD = 15</a:t>
            </a:r>
          </a:p>
          <a:p>
            <a:r>
              <a:rPr lang="en-US" dirty="0" smtClean="0"/>
              <a:t>% Positive = 18.9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dirty="0" smtClean="0"/>
              <a:t>093HA</a:t>
            </a:r>
            <a:endParaRPr lang="en-US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286000" y="1447800"/>
            <a:ext cx="6404039" cy="53105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" y="1447801"/>
            <a:ext cx="2174966" cy="2057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212728" y="4419600"/>
            <a:ext cx="189014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Stat3: </a:t>
            </a:r>
          </a:p>
          <a:p>
            <a:r>
              <a:rPr lang="en-US" dirty="0" err="1" smtClean="0"/>
              <a:t>Nuc</a:t>
            </a:r>
            <a:r>
              <a:rPr lang="en-US" dirty="0" smtClean="0"/>
              <a:t> OD = 14</a:t>
            </a:r>
          </a:p>
          <a:p>
            <a:r>
              <a:rPr lang="en-US" dirty="0" smtClean="0"/>
              <a:t>% Positive = 9.8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dirty="0" smtClean="0"/>
              <a:t>095JM</a:t>
            </a:r>
            <a:endParaRPr lang="en-US" dirty="0"/>
          </a:p>
        </p:txBody>
      </p:sp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23916" y="1524000"/>
            <a:ext cx="6262884" cy="52626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267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0" y="1524000"/>
            <a:ext cx="2297043" cy="1828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212728" y="4419600"/>
            <a:ext cx="189014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Stat3: </a:t>
            </a:r>
          </a:p>
          <a:p>
            <a:r>
              <a:rPr lang="en-US" dirty="0" err="1" smtClean="0"/>
              <a:t>Nuc</a:t>
            </a:r>
            <a:r>
              <a:rPr lang="en-US" dirty="0" smtClean="0"/>
              <a:t> OD = 17</a:t>
            </a:r>
          </a:p>
          <a:p>
            <a:r>
              <a:rPr lang="en-US" dirty="0" smtClean="0"/>
              <a:t>% Positive = 23.3</a:t>
            </a:r>
          </a:p>
        </p:txBody>
      </p:sp>
    </p:spTree>
    <p:extLst>
      <p:ext uri="{BB962C8B-B14F-4D97-AF65-F5344CB8AC3E}">
        <p14:creationId xmlns:p14="http://schemas.microsoft.com/office/powerpoint/2010/main" val="33871941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dirty="0" smtClean="0"/>
              <a:t>096AM</a:t>
            </a:r>
            <a:endParaRPr lang="en-US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350786" y="1524000"/>
            <a:ext cx="6324279" cy="533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0" y="1524001"/>
            <a:ext cx="2201133" cy="1752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212728" y="4419600"/>
            <a:ext cx="189014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Stat3: </a:t>
            </a:r>
          </a:p>
          <a:p>
            <a:r>
              <a:rPr lang="en-US" dirty="0" err="1" smtClean="0"/>
              <a:t>Nuc</a:t>
            </a:r>
            <a:r>
              <a:rPr lang="en-US" dirty="0" smtClean="0"/>
              <a:t> OD = 14</a:t>
            </a:r>
          </a:p>
          <a:p>
            <a:r>
              <a:rPr lang="en-US" dirty="0" smtClean="0"/>
              <a:t>% Positive = 23.3</a:t>
            </a:r>
          </a:p>
        </p:txBody>
      </p:sp>
    </p:spTree>
    <p:extLst>
      <p:ext uri="{BB962C8B-B14F-4D97-AF65-F5344CB8AC3E}">
        <p14:creationId xmlns:p14="http://schemas.microsoft.com/office/powerpoint/2010/main" val="25624007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6</TotalTime>
  <Words>44</Words>
  <Application>Microsoft Office PowerPoint</Application>
  <PresentationFormat>On-screen Show (4:3)</PresentationFormat>
  <Paragraphs>16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088DD</vt:lpstr>
      <vt:lpstr>093HA</vt:lpstr>
      <vt:lpstr>095JM</vt:lpstr>
      <vt:lpstr>096AM</vt:lpstr>
    </vt:vector>
  </TitlesOfParts>
  <Company>Novartis Pharma A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 Stat3 Stain SH008 Human Sample</dc:title>
  <dc:creator>Lab_HATAKSH1</dc:creator>
  <cp:lastModifiedBy>Hatakeyama, Shinji</cp:lastModifiedBy>
  <cp:revision>66</cp:revision>
  <dcterms:created xsi:type="dcterms:W3CDTF">2012-11-29T15:22:01Z</dcterms:created>
  <dcterms:modified xsi:type="dcterms:W3CDTF">2013-06-10T13:53:21Z</dcterms:modified>
</cp:coreProperties>
</file>